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 horzBarState="maximized">
    <p:restoredLeft sz="18464" autoAdjust="0"/>
    <p:restoredTop sz="94660"/>
  </p:normalViewPr>
  <p:slideViewPr>
    <p:cSldViewPr snapToGrid="0">
      <p:cViewPr>
        <p:scale>
          <a:sx n="100" d="100"/>
          <a:sy n="100" d="100"/>
        </p:scale>
        <p:origin x="954" y="5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9105A4C5-8465-48F6-8D01-E9412B90C7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0B320149-0FB2-4CA4-A7BA-B3F072E450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8561E3F2-ED7A-4652-B4BF-4E9667F6A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DECEEB3F-CF92-4C84-A2D8-D94F8A934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55277BCE-947A-49A4-8722-9F45725B5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5083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83E56C73-4313-4A7F-A2FC-64E39C1810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375F26ED-12FF-4920-B0DE-05448C2A61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4E08F437-4804-43BC-995A-CA623835E9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7F907C74-0BC4-4D08-AB72-D9A13196F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BD9D19F5-B99F-4453-9924-9E4EA48E4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2506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F0FC7E0B-16AB-44DC-8A7E-F6AD51EA34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A394B3B8-7BFD-4118-B852-A7134DBC30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467FB7FF-E51C-4077-98E1-0F2C83EB5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25E85153-39B1-4C19-A170-D241540C8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BAB539C3-E286-43B1-9BC1-C2CF9D9C8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9965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5521BC54-FFB7-4D89-9BA1-F4C626E13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9668BB4F-1D0B-4AC8-9B1B-3A7C4F7C9B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504F599C-FF4B-4EBB-8DB1-1B9020E2E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4EA43BE8-D92A-4AC5-8CBF-452FDDC66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9C9C54A3-3801-493A-8463-0AB200722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3268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0D757B97-5198-4198-8E76-73E362F3AC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2FEF5829-41B9-4E63-B855-CB6F963D6A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6190E4D7-30AE-4011-9969-C99A11838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D8D35264-67FE-43BB-94A9-D14EBDB97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448DB01A-F372-482D-B39E-6B259F706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9775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C84BAA6B-F519-4547-BC59-D08485E8A8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7DAD6713-CA53-4B5B-831F-04536205EE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6C1C5489-AB61-4D70-B31A-59EE054ED0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7645C2E8-5C02-44E8-AAB4-AD15FFA6D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5F1C76C0-008D-426C-AE25-87532CA052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85736E16-5D15-412C-AF17-4F76C7A47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3693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356C53EA-7B75-4201-9517-7757F10AA7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0360DD01-44D3-416A-92C3-AC935A59D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B453EEB3-D736-4EE4-9DFD-5C12110ACA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xmlns="" id="{79EDC1E7-98D9-41F8-8C8D-98D229094D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xmlns="" id="{74688C53-5A6B-4BF4-9E89-A3B176992B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xmlns="" id="{A163B654-FA86-4E17-BA28-BF15C5816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xmlns="" id="{DD26303A-4A34-42CA-8D29-4A6285C9B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xmlns="" id="{3D96B2C7-82D7-47CB-80A1-D890219F3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3649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CE8765C9-66DB-4EB8-A5D0-D9199FED80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xmlns="" id="{0FAAF75D-C7A9-4CAC-BD91-483A8410E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xmlns="" id="{B0E2253E-3A99-4865-994F-320E0266A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xmlns="" id="{9C5731D9-747C-4B9B-B659-5B4F0055A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0982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xmlns="" id="{53E1EEF3-C9FD-4460-8821-F4DDDAE82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xmlns="" id="{87C6262B-0F7E-42F5-B0A6-278A7C505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xmlns="" id="{891245A3-D9D4-496C-B76D-13D63FB2B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1404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BCBD85AB-4784-4233-BC63-B54129FB2D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27799216-5898-4EF7-85FA-86679A9194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7E005931-E1E2-4B82-9767-CA887E1B20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BE91608F-A6C3-4117-8EDC-3C977B0B9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222B38A2-13B7-4F86-8721-82C4AE163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8B3D5B76-499D-445D-827B-A0D99D612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7312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0447F3F3-3ADC-4F04-9564-772BC1A943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xmlns="" id="{1869117E-5DAA-464B-A741-547151B36F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66AF6EB4-2F58-48AE-AADE-64E75253EF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92FE4959-4F4F-44B2-B1F9-DD2B68502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39950023-7AA9-4AF2-B81C-718D0425B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58070F0A-4739-4445-B8F4-600AD1223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5621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xmlns="" id="{9608ECE4-5CEB-4B23-BAA6-2EF02622B0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DEA83B2A-29F7-4EFB-9BA7-7D91AB0799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61AEE196-3157-4E34-BA2F-F30E085648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1FD7AE-A55E-4A7E-B2CD-0EA91B2E156B}" type="datetimeFigureOut">
              <a:rPr lang="es-ES" smtClean="0"/>
              <a:pPr/>
              <a:t>20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93F5CF37-3BF2-44C8-AD22-96E85B39C4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68677FAB-723A-47D0-9102-AA7650CB12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58591-0242-48D7-9A67-A10BF5A5B56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8594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xmlns="" id="{218E1673-DEE7-4D86-8F7F-635FE23309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945779"/>
              </p:ext>
            </p:extLst>
          </p:nvPr>
        </p:nvGraphicFramePr>
        <p:xfrm>
          <a:off x="851420" y="693512"/>
          <a:ext cx="10489160" cy="4351333"/>
        </p:xfrm>
        <a:graphic>
          <a:graphicData uri="http://schemas.openxmlformats.org/drawingml/2006/table">
            <a:tbl>
              <a:tblPr/>
              <a:tblGrid>
                <a:gridCol w="301288">
                  <a:extLst>
                    <a:ext uri="{9D8B030D-6E8A-4147-A177-3AD203B41FA5}">
                      <a16:colId xmlns:a16="http://schemas.microsoft.com/office/drawing/2014/main" xmlns="" val="952615538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2476273119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2157188484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2892323266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2855501080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508558479"/>
                    </a:ext>
                  </a:extLst>
                </a:gridCol>
                <a:gridCol w="458389">
                  <a:extLst>
                    <a:ext uri="{9D8B030D-6E8A-4147-A177-3AD203B41FA5}">
                      <a16:colId xmlns:a16="http://schemas.microsoft.com/office/drawing/2014/main" xmlns="" val="2064421480"/>
                    </a:ext>
                  </a:extLst>
                </a:gridCol>
                <a:gridCol w="458389">
                  <a:extLst>
                    <a:ext uri="{9D8B030D-6E8A-4147-A177-3AD203B41FA5}">
                      <a16:colId xmlns:a16="http://schemas.microsoft.com/office/drawing/2014/main" xmlns="" val="668024520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293009178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356045350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087367147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853771817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384837396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53405403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1732847133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448655742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1258644226"/>
                    </a:ext>
                  </a:extLst>
                </a:gridCol>
                <a:gridCol w="400283">
                  <a:extLst>
                    <a:ext uri="{9D8B030D-6E8A-4147-A177-3AD203B41FA5}">
                      <a16:colId xmlns:a16="http://schemas.microsoft.com/office/drawing/2014/main" xmlns="" val="1276030710"/>
                    </a:ext>
                  </a:extLst>
                </a:gridCol>
                <a:gridCol w="400283">
                  <a:extLst>
                    <a:ext uri="{9D8B030D-6E8A-4147-A177-3AD203B41FA5}">
                      <a16:colId xmlns:a16="http://schemas.microsoft.com/office/drawing/2014/main" xmlns="" val="3171986268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4200129729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461943406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4067100406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4161162870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560873993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32090846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1780921966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811288272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2412619965"/>
                    </a:ext>
                  </a:extLst>
                </a:gridCol>
                <a:gridCol w="374459">
                  <a:extLst>
                    <a:ext uri="{9D8B030D-6E8A-4147-A177-3AD203B41FA5}">
                      <a16:colId xmlns:a16="http://schemas.microsoft.com/office/drawing/2014/main" xmlns="" val="3122216965"/>
                    </a:ext>
                  </a:extLst>
                </a:gridCol>
                <a:gridCol w="374459">
                  <a:extLst>
                    <a:ext uri="{9D8B030D-6E8A-4147-A177-3AD203B41FA5}">
                      <a16:colId xmlns:a16="http://schemas.microsoft.com/office/drawing/2014/main" xmlns="" val="565401886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304940802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240230957"/>
                    </a:ext>
                  </a:extLst>
                </a:gridCol>
                <a:gridCol w="296985">
                  <a:extLst>
                    <a:ext uri="{9D8B030D-6E8A-4147-A177-3AD203B41FA5}">
                      <a16:colId xmlns:a16="http://schemas.microsoft.com/office/drawing/2014/main" xmlns="" val="1888217538"/>
                    </a:ext>
                  </a:extLst>
                </a:gridCol>
              </a:tblGrid>
              <a:tr h="133985"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F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219406587"/>
                  </a:ext>
                </a:extLst>
              </a:tr>
              <a:tr h="267971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ory of infections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ory of antibiotherapy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ory of infections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ory</a:t>
                      </a:r>
                      <a:r>
                        <a:rPr lang="es-E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</a:t>
                      </a:r>
                      <a:r>
                        <a:rPr lang="es-E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biotherapy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ory of infections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ory of antibiotherapy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787686093"/>
                  </a:ext>
                </a:extLst>
              </a:tr>
              <a:tr h="1397277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ginal 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rinary tract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orhinolaryngology 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iratory tract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kin 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strointestinal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fancy (pre/puberty)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ult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ergies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specific food intolerance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s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ginal 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rinary tract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orhinolaryngology 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iratory tract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kin 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strointestinal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fancy (pre/puberty)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ult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ergies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specific food intolerance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s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ginal 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rinary tract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orhinolaryngology 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iratory tract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kin 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strointestinal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fancy (pre/puberty)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ult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ergies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specific food intolerance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s</a:t>
                      </a:r>
                    </a:p>
                  </a:txBody>
                  <a:tcPr marL="6380" marR="6380" marT="6380" marB="0" vert="vert27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48429149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D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05539016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HPV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D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V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31657713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67128578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67716649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V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D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09443004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V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D/ M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72647854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26330787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V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10414362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09622936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63796081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D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87699202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74575091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V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78585258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54578288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V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D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20255833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V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43261178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D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/ L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D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290749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60795368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/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V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89950163"/>
                  </a:ext>
                </a:extLst>
              </a:tr>
              <a:tr h="127605"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80" marR="6380" marT="638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5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4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80" marR="6380" marT="638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69570741"/>
                  </a:ext>
                </a:extLst>
              </a:tr>
            </a:tbl>
          </a:graphicData>
        </a:graphic>
      </p:graphicFrame>
      <p:pic>
        <p:nvPicPr>
          <p:cNvPr id="7" name="Imagen 6">
            <a:extLst>
              <a:ext uri="{FF2B5EF4-FFF2-40B4-BE49-F238E27FC236}">
                <a16:creationId xmlns:a16="http://schemas.microsoft.com/office/drawing/2014/main" xmlns="" id="{DC737613-042C-4FBC-9C7F-DA6739C06162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70734" y="4406427"/>
            <a:ext cx="2777152" cy="2279964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8289089B-F0F7-43FC-8722-1A5B97E2AB92}"/>
              </a:ext>
            </a:extLst>
          </p:cNvPr>
          <p:cNvSpPr txBox="1"/>
          <p:nvPr/>
        </p:nvSpPr>
        <p:spPr>
          <a:xfrm>
            <a:off x="508000" y="171609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</a:t>
            </a:r>
            <a:r>
              <a:rPr lang="es-ES" dirty="0"/>
              <a:t>. 1</a:t>
            </a:r>
          </a:p>
        </p:txBody>
      </p:sp>
    </p:spTree>
    <p:extLst>
      <p:ext uri="{BB962C8B-B14F-4D97-AF65-F5344CB8AC3E}">
        <p14:creationId xmlns:p14="http://schemas.microsoft.com/office/powerpoint/2010/main" val="29760170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99</TotalTime>
  <Words>343</Words>
  <Application>Microsoft Office PowerPoint</Application>
  <PresentationFormat>Personalizado</PresentationFormat>
  <Paragraphs>64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udio</dc:creator>
  <cp:lastModifiedBy>manucruz_2006@hotmail.com</cp:lastModifiedBy>
  <cp:revision>13</cp:revision>
  <dcterms:created xsi:type="dcterms:W3CDTF">2020-10-12T19:41:53Z</dcterms:created>
  <dcterms:modified xsi:type="dcterms:W3CDTF">2022-10-20T13:29:33Z</dcterms:modified>
</cp:coreProperties>
</file>